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57" r:id="rId2"/>
  </p:sldIdLst>
  <p:sldSz cx="6858000" cy="12192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5005" autoAdjust="0"/>
    <p:restoredTop sz="94660"/>
  </p:normalViewPr>
  <p:slideViewPr>
    <p:cSldViewPr snapToGrid="0">
      <p:cViewPr varScale="1">
        <p:scale>
          <a:sx n="62" d="100"/>
          <a:sy n="62" d="100"/>
        </p:scale>
        <p:origin x="289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3" d="100"/>
          <a:sy n="63" d="100"/>
        </p:scale>
        <p:origin x="3206" y="77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لرأس 1">
            <a:extLst>
              <a:ext uri="{FF2B5EF4-FFF2-40B4-BE49-F238E27FC236}">
                <a16:creationId xmlns:a16="http://schemas.microsoft.com/office/drawing/2014/main" id="{7757C77A-6C17-F89B-D093-E835485C37D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518160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عنصر نائب للتاريخ 2">
            <a:extLst>
              <a:ext uri="{FF2B5EF4-FFF2-40B4-BE49-F238E27FC236}">
                <a16:creationId xmlns:a16="http://schemas.microsoft.com/office/drawing/2014/main" id="{AE498DA8-9E16-166C-4515-2ECB28A6639E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2117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fld id="{BC569B7B-B800-40FF-B64A-CE730F6E3B98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4" name="عنصر نائب للتذييل 3">
            <a:extLst>
              <a:ext uri="{FF2B5EF4-FFF2-40B4-BE49-F238E27FC236}">
                <a16:creationId xmlns:a16="http://schemas.microsoft.com/office/drawing/2014/main" id="{0D6974A3-5D83-A074-F71B-22337F45DC1F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518160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عنصر نائب لرقم الشريحة 4">
            <a:extLst>
              <a:ext uri="{FF2B5EF4-FFF2-40B4-BE49-F238E27FC236}">
                <a16:creationId xmlns:a16="http://schemas.microsoft.com/office/drawing/2014/main" id="{42827934-7DB6-035F-E7EB-98F280E03C04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2117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fld id="{89AC26E2-C184-42D9-A594-7B477E0BBD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34936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998BD0-90CC-47C3-805A-125B4A5ED851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921125" y="857250"/>
            <a:ext cx="13017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D59AFD-D404-4B5D-9400-3542F04868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57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صورة الشريحة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عنصر نائب للملاحظا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عنصر نائب لرقم الشريحة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CF6CFE-5844-4750-9EEC-9904C9E9089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4261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شريحة عنو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ar-SA"/>
              <a:t>انقر لتحرير نمط العنوان الفرعي للشكل الرئيسي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768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عنوان ونص عمودي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00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عنوان ونص عمودي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236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عنوان ومحتو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2542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عنوان المقط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51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محتوي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841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مقارن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648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عنوان فق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712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فار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07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محتوى مع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059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صورة مع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ar-SA"/>
              <a:t>انقر فوق الأيقونة لإضافة صورة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0249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ar-SA"/>
              <a:t>انقر لتحرير نمط عنوان الشكل الرئيسي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D77A6-7B12-4F62-985D-910452806B1C}" type="datetimeFigureOut">
              <a:rPr lang="en-US" smtClean="0"/>
              <a:t>12/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605994-1899-4759-94DA-6C043D523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74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مربع نص 1">
            <a:extLst>
              <a:ext uri="{FF2B5EF4-FFF2-40B4-BE49-F238E27FC236}">
                <a16:creationId xmlns:a16="http://schemas.microsoft.com/office/drawing/2014/main" id="{7DA85AFA-F399-D6E7-BB3F-21C0506C6EEF}"/>
              </a:ext>
            </a:extLst>
          </p:cNvPr>
          <p:cNvSpPr txBox="1"/>
          <p:nvPr/>
        </p:nvSpPr>
        <p:spPr>
          <a:xfrm>
            <a:off x="1" y="5932293"/>
            <a:ext cx="640257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rtl="0"/>
            <a:r>
              <a:rPr lang="en-US" sz="1200" b="1" dirty="0"/>
              <a:t>S7 Fig. </a:t>
            </a:r>
            <a:r>
              <a:rPr lang="en-US" sz="1200" dirty="0"/>
              <a:t>Effect of </a:t>
            </a:r>
            <a:r>
              <a:rPr lang="en-US" sz="1200" i="1" dirty="0"/>
              <a:t>P. lividus </a:t>
            </a:r>
            <a:r>
              <a:rPr lang="en-US" sz="1200" dirty="0"/>
              <a:t>gonadal extract on the toxicity in rats, GOT (AST) Glutamic—Oxaloacetic Transaminase, Alkaline phosphatase (ALP),  GPT (ALT) Glutamic – Pyruvic Transaminase, Urea, uric acid, and creatinine levels were detected. All the data were analyzed using one-way ANOVA followed by Tukey Pairwise Comparisons. Values are expressed as mean ± SE; n = 5 rats for each group. Different superscripts on the columns are significantly different at p≤0.05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F9016D0-F4B6-D39C-2FD7-69945A454F3D}"/>
              </a:ext>
            </a:extLst>
          </p:cNvPr>
          <p:cNvGrpSpPr/>
          <p:nvPr/>
        </p:nvGrpSpPr>
        <p:grpSpPr>
          <a:xfrm>
            <a:off x="0" y="353310"/>
            <a:ext cx="6551800" cy="5431538"/>
            <a:chOff x="0" y="353310"/>
            <a:chExt cx="6551800" cy="5431538"/>
          </a:xfrm>
        </p:grpSpPr>
        <p:graphicFrame>
          <p:nvGraphicFramePr>
            <p:cNvPr id="15" name="عنصر 14">
              <a:extLst>
                <a:ext uri="{FF2B5EF4-FFF2-40B4-BE49-F238E27FC236}">
                  <a16:creationId xmlns:a16="http://schemas.microsoft.com/office/drawing/2014/main" id="{B65E3F14-94DC-2FC8-29FA-A5D639375AE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0" y="353758"/>
            <a:ext cx="2135187" cy="26901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2134889" imgH="3431514" progId="Prism9.Document">
                    <p:embed/>
                  </p:oleObj>
                </mc:Choice>
                <mc:Fallback>
                  <p:oleObj name="Prism 9" r:id="rId3" imgW="2134889" imgH="3431514" progId="Prism9.Document">
                    <p:embed/>
                    <p:pic>
                      <p:nvPicPr>
                        <p:cNvPr id="15" name="عنصر 14">
                          <a:extLst>
                            <a:ext uri="{FF2B5EF4-FFF2-40B4-BE49-F238E27FC236}">
                              <a16:creationId xmlns:a16="http://schemas.microsoft.com/office/drawing/2014/main" id="{B65E3F14-94DC-2FC8-29FA-A5D639375AE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0" y="353758"/>
                          <a:ext cx="2135187" cy="26901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عنصر 15">
              <a:extLst>
                <a:ext uri="{FF2B5EF4-FFF2-40B4-BE49-F238E27FC236}">
                  <a16:creationId xmlns:a16="http://schemas.microsoft.com/office/drawing/2014/main" id="{AAC67261-A8D6-A1A6-1816-0C98B4887C9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117913" y="362550"/>
            <a:ext cx="2219325" cy="26901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2218758" imgH="3431514" progId="Prism9.Document">
                    <p:embed/>
                  </p:oleObj>
                </mc:Choice>
                <mc:Fallback>
                  <p:oleObj name="Prism 9" r:id="rId5" imgW="2218758" imgH="3431514" progId="Prism9.Document">
                    <p:embed/>
                    <p:pic>
                      <p:nvPicPr>
                        <p:cNvPr id="16" name="عنصر 15">
                          <a:extLst>
                            <a:ext uri="{FF2B5EF4-FFF2-40B4-BE49-F238E27FC236}">
                              <a16:creationId xmlns:a16="http://schemas.microsoft.com/office/drawing/2014/main" id="{AAC67261-A8D6-A1A6-1816-0C98B4887C9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117913" y="362550"/>
                          <a:ext cx="2219325" cy="26901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عنصر 16">
              <a:extLst>
                <a:ext uri="{FF2B5EF4-FFF2-40B4-BE49-F238E27FC236}">
                  <a16:creationId xmlns:a16="http://schemas.microsoft.com/office/drawing/2014/main" id="{013E2B3D-9FC3-1AAF-2BB2-1826D378FDD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416613" y="353310"/>
            <a:ext cx="2135187" cy="26901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2134889" imgH="3431514" progId="Prism9.Document">
                    <p:embed/>
                  </p:oleObj>
                </mc:Choice>
                <mc:Fallback>
                  <p:oleObj name="Prism 9" r:id="rId7" imgW="2134889" imgH="3431514" progId="Prism9.Document">
                    <p:embed/>
                    <p:pic>
                      <p:nvPicPr>
                        <p:cNvPr id="17" name="عنصر 16">
                          <a:extLst>
                            <a:ext uri="{FF2B5EF4-FFF2-40B4-BE49-F238E27FC236}">
                              <a16:creationId xmlns:a16="http://schemas.microsoft.com/office/drawing/2014/main" id="{013E2B3D-9FC3-1AAF-2BB2-1826D378FDD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416613" y="353310"/>
                          <a:ext cx="2135187" cy="26901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" name="عنصر 17">
              <a:extLst>
                <a:ext uri="{FF2B5EF4-FFF2-40B4-BE49-F238E27FC236}">
                  <a16:creationId xmlns:a16="http://schemas.microsoft.com/office/drawing/2014/main" id="{EF9A55C9-A947-F124-6FD1-10F7EB604F9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174" y="3077104"/>
            <a:ext cx="2132013" cy="26901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2131649" imgH="3431514" progId="Prism9.Document">
                    <p:embed/>
                  </p:oleObj>
                </mc:Choice>
                <mc:Fallback>
                  <p:oleObj name="Prism 9" r:id="rId9" imgW="2131649" imgH="3431514" progId="Prism9.Document">
                    <p:embed/>
                    <p:pic>
                      <p:nvPicPr>
                        <p:cNvPr id="18" name="عنصر 17">
                          <a:extLst>
                            <a:ext uri="{FF2B5EF4-FFF2-40B4-BE49-F238E27FC236}">
                              <a16:creationId xmlns:a16="http://schemas.microsoft.com/office/drawing/2014/main" id="{EF9A55C9-A947-F124-6FD1-10F7EB604F9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174" y="3077104"/>
                          <a:ext cx="2132013" cy="26901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عنصر 18">
              <a:extLst>
                <a:ext uri="{FF2B5EF4-FFF2-40B4-BE49-F238E27FC236}">
                  <a16:creationId xmlns:a16="http://schemas.microsoft.com/office/drawing/2014/main" id="{155A5655-9DD7-25ED-4F7B-023A52844B3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117913" y="3077104"/>
            <a:ext cx="2055813" cy="26901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1" imgW="2055699" imgH="3431514" progId="Prism9.Document">
                    <p:embed/>
                  </p:oleObj>
                </mc:Choice>
                <mc:Fallback>
                  <p:oleObj name="Prism 9" r:id="rId11" imgW="2055699" imgH="3431514" progId="Prism9.Document">
                    <p:embed/>
                    <p:pic>
                      <p:nvPicPr>
                        <p:cNvPr id="19" name="عنصر 18">
                          <a:extLst>
                            <a:ext uri="{FF2B5EF4-FFF2-40B4-BE49-F238E27FC236}">
                              <a16:creationId xmlns:a16="http://schemas.microsoft.com/office/drawing/2014/main" id="{155A5655-9DD7-25ED-4F7B-023A52844B3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117913" y="3077104"/>
                          <a:ext cx="2055813" cy="26901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عنصر 19">
              <a:extLst>
                <a:ext uri="{FF2B5EF4-FFF2-40B4-BE49-F238E27FC236}">
                  <a16:creationId xmlns:a16="http://schemas.microsoft.com/office/drawing/2014/main" id="{3F825071-7087-6B93-ACAD-626BE58CC368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232463" y="3094687"/>
            <a:ext cx="2170113" cy="26901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3" imgW="2169804" imgH="3431514" progId="Prism9.Document">
                    <p:embed/>
                  </p:oleObj>
                </mc:Choice>
                <mc:Fallback>
                  <p:oleObj name="Prism 9" r:id="rId13" imgW="2169804" imgH="3431514" progId="Prism9.Document">
                    <p:embed/>
                    <p:pic>
                      <p:nvPicPr>
                        <p:cNvPr id="20" name="عنصر 19">
                          <a:extLst>
                            <a:ext uri="{FF2B5EF4-FFF2-40B4-BE49-F238E27FC236}">
                              <a16:creationId xmlns:a16="http://schemas.microsoft.com/office/drawing/2014/main" id="{3F825071-7087-6B93-ACAD-626BE58CC36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4232463" y="3094687"/>
                          <a:ext cx="2170113" cy="26901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129283097"/>
      </p:ext>
    </p:extLst>
  </p:cSld>
  <p:clrMapOvr>
    <a:masterClrMapping/>
  </p:clrMapOvr>
</p:sld>
</file>

<file path=ppt/theme/theme1.xml><?xml version="1.0" encoding="utf-8"?>
<a:theme xmlns:a="http://schemas.openxmlformats.org/drawingml/2006/main" name="نسق Office">
  <a:themeElements>
    <a:clrScheme name="نسق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نسق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نسق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3.xml><?xml version="1.0" encoding="utf-8"?>
<a:theme xmlns:a="http://schemas.openxmlformats.org/drawingml/2006/main" name="نسق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25</TotalTime>
  <Words>94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نسق Offic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عرض تقديمي في PowerPoint</dc:title>
  <dc:creator>nehal nagy</dc:creator>
  <cp:lastModifiedBy>HYD OFF31</cp:lastModifiedBy>
  <cp:revision>77</cp:revision>
  <dcterms:created xsi:type="dcterms:W3CDTF">2023-11-28T07:45:43Z</dcterms:created>
  <dcterms:modified xsi:type="dcterms:W3CDTF">2024-12-07T14:36:07Z</dcterms:modified>
</cp:coreProperties>
</file>